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583" autoAdjust="0"/>
    <p:restoredTop sz="88400" autoAdjust="0"/>
  </p:normalViewPr>
  <p:slideViewPr>
    <p:cSldViewPr snapToGrid="0" snapToObjects="1">
      <p:cViewPr varScale="1">
        <p:scale>
          <a:sx n="101" d="100"/>
          <a:sy n="101" d="100"/>
        </p:scale>
        <p:origin x="156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254102-9EEE-8047-9BDC-3665EA0D766B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a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20DCF8-AA3D-5B4E-9891-922D9CBAFC12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5397761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1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ncentration-response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urves to acetylcholine in male OF-1 mice common carotid arteries in the absence (No serum) or presence of 1% (A) or 3% (B) ischemic stroke serum. Results are mean ± SEM of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= 17 per group (A) and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= 22 per group (B). </a:t>
            </a:r>
            <a:endParaRPr lang="es-E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ca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20DCF8-AA3D-5B4E-9891-922D9CBAFC12}" type="slidenum">
              <a:rPr lang="ca-ES" smtClean="0"/>
              <a:t>1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8686356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011319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629737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767004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617633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924844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415777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640373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692338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619346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995568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056165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92B92-7A68-A848-A325-2BE900472329}" type="datetimeFigureOut">
              <a:rPr lang="ca-ES" smtClean="0"/>
              <a:t>28/6/2022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63AF3-E463-AC42-A5B1-CB6282BF5167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475914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uadroTexto 11">
            <a:extLst>
              <a:ext uri="{FF2B5EF4-FFF2-40B4-BE49-F238E27FC236}">
                <a16:creationId xmlns:a16="http://schemas.microsoft.com/office/drawing/2014/main" id="{44B3D5C1-5906-7148-8EAC-DCA685824FB1}"/>
              </a:ext>
            </a:extLst>
          </p:cNvPr>
          <p:cNvSpPr txBox="1"/>
          <p:nvPr/>
        </p:nvSpPr>
        <p:spPr>
          <a:xfrm>
            <a:off x="1062037" y="23025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1F88635A-540C-044F-9F02-516546E09080}"/>
              </a:ext>
            </a:extLst>
          </p:cNvPr>
          <p:cNvSpPr txBox="1"/>
          <p:nvPr/>
        </p:nvSpPr>
        <p:spPr>
          <a:xfrm>
            <a:off x="5240724" y="23025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Imagen 2" descr="Diagrama&#10;&#10;Descripción generada automáticamente">
            <a:extLst>
              <a:ext uri="{FF2B5EF4-FFF2-40B4-BE49-F238E27FC236}">
                <a16:creationId xmlns:a16="http://schemas.microsoft.com/office/drawing/2014/main" id="{E67F22F7-E417-6444-9B0D-2C04379285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11545" y="2779870"/>
            <a:ext cx="3771900" cy="2552700"/>
          </a:xfrm>
          <a:prstGeom prst="rect">
            <a:avLst/>
          </a:prstGeom>
        </p:spPr>
      </p:pic>
      <p:pic>
        <p:nvPicPr>
          <p:cNvPr id="5" name="Imagen 4" descr="Diagrama&#10;&#10;Descripción generada automáticamente">
            <a:extLst>
              <a:ext uri="{FF2B5EF4-FFF2-40B4-BE49-F238E27FC236}">
                <a16:creationId xmlns:a16="http://schemas.microsoft.com/office/drawing/2014/main" id="{5D807E32-BED1-7A4C-8E58-B72C6BB7A2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6528" y="2779870"/>
            <a:ext cx="3771900" cy="2552700"/>
          </a:xfrm>
          <a:prstGeom prst="rect">
            <a:avLst/>
          </a:prstGeom>
        </p:spPr>
      </p:pic>
      <p:sp>
        <p:nvSpPr>
          <p:cNvPr id="8" name="QuadreDeText 7">
            <a:extLst>
              <a:ext uri="{FF2B5EF4-FFF2-40B4-BE49-F238E27FC236}">
                <a16:creationId xmlns:a16="http://schemas.microsoft.com/office/drawing/2014/main" id="{3823E27E-A78E-2B44-5778-14BD373F4EBD}"/>
              </a:ext>
            </a:extLst>
          </p:cNvPr>
          <p:cNvSpPr txBox="1"/>
          <p:nvPr/>
        </p:nvSpPr>
        <p:spPr>
          <a:xfrm>
            <a:off x="914399" y="5621045"/>
            <a:ext cx="8277225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upplementary Figure 1.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Concentration-response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curves to acetylcholine in male OF-1 mice common carotid arteries in the absence (No serum) or presence of 1% (A) or 3% (B) ischemic stroke serum. Results are mean ± SEM of </a:t>
            </a:r>
            <a:r>
              <a:rPr kumimoji="0" lang="en-US" sz="14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n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 = 17 per group (A) and </a:t>
            </a:r>
            <a:r>
              <a:rPr kumimoji="0" lang="en-US" sz="14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n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= 22 per group (B). </a:t>
            </a:r>
            <a:endParaRPr kumimoji="0" lang="es-E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  <p:sp>
        <p:nvSpPr>
          <p:cNvPr id="11" name="QuadreDeText 10">
            <a:extLst>
              <a:ext uri="{FF2B5EF4-FFF2-40B4-BE49-F238E27FC236}">
                <a16:creationId xmlns:a16="http://schemas.microsoft.com/office/drawing/2014/main" id="{6F130505-F68F-4F0E-125F-50945E2BB402}"/>
              </a:ext>
            </a:extLst>
          </p:cNvPr>
          <p:cNvSpPr txBox="1"/>
          <p:nvPr/>
        </p:nvSpPr>
        <p:spPr>
          <a:xfrm>
            <a:off x="245268" y="60966"/>
            <a:ext cx="9415464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ticle title: 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rum from stroke patients with high grade carotid stenosis promotes cyclooxygenase-dependent endothelial dysfunction in non-ischemic mice carotid arteries</a:t>
            </a:r>
          </a:p>
          <a:p>
            <a:endParaRPr lang="en-US" sz="1200" i="0" dirty="0">
              <a:solidFill>
                <a:srgbClr val="333333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Journal name: 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anslational Stroke Research</a:t>
            </a:r>
          </a:p>
          <a:p>
            <a:endParaRPr lang="en-US" sz="1200" i="0" dirty="0">
              <a:solidFill>
                <a:srgbClr val="333333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uthor names: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ídia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uertas-Umbert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úria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uig, Mercedes Camacho, Ana Paula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ntas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Rebeca Marín, Joan Martí-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àbregas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Elena Jiménez-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Xarrié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Sonia Benítez, Pol Camps-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nom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Francesc Jiménez-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ltayó</a:t>
            </a:r>
            <a:endParaRPr lang="en-US" sz="1200" i="0" dirty="0">
              <a:solidFill>
                <a:srgbClr val="333333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i="0" dirty="0">
              <a:solidFill>
                <a:srgbClr val="333333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b="1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filiation and e-mail address of the corresponding author: 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partment of Pharmacology, Therapeutics and Toxicology, School of Medicine,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niversitat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utònoma</a:t>
            </a:r>
            <a:r>
              <a:rPr lang="en-US" sz="120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e Barcelona, Barcelona, Spain; francesc.jimenez@uab.cat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51650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75</TotalTime>
  <Words>226</Words>
  <Application>Microsoft Office PowerPoint</Application>
  <PresentationFormat>Paper A4 (210 x 297 mm)</PresentationFormat>
  <Paragraphs>12</Paragraphs>
  <Slides>1</Slides>
  <Notes>1</Notes>
  <HiddenSlides>0</HiddenSlides>
  <MMClips>0</MMClips>
  <ScaleCrop>false</ScaleCrop>
  <HeadingPairs>
    <vt:vector size="6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ídia Puertas Umbert</dc:creator>
  <cp:lastModifiedBy>Francesc Jimenez Altayo</cp:lastModifiedBy>
  <cp:revision>120</cp:revision>
  <dcterms:created xsi:type="dcterms:W3CDTF">2020-04-08T11:10:44Z</dcterms:created>
  <dcterms:modified xsi:type="dcterms:W3CDTF">2022-06-28T05:42:34Z</dcterms:modified>
</cp:coreProperties>
</file>